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69" autoAdjust="0"/>
    <p:restoredTop sz="94660"/>
  </p:normalViewPr>
  <p:slideViewPr>
    <p:cSldViewPr snapToGrid="0">
      <p:cViewPr varScale="1">
        <p:scale>
          <a:sx n="82" d="100"/>
          <a:sy n="82" d="100"/>
        </p:scale>
        <p:origin x="44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8C10F7-367B-D370-F0AC-5A035F087C8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4757A6F-6E71-BF36-0B8C-0C8E8009B4A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BF9B800-AC84-8BD8-29C1-5404CFBE47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0FC09-F9E9-4733-8766-1C4D2FF1BA88}" type="datetimeFigureOut">
              <a:rPr lang="en-US" smtClean="0"/>
              <a:t>5/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6C39E2-9521-8850-28F2-06223D06CC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B47FAF-7C81-0141-2A3B-6B85C1FB87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B00E1D-3532-4D1D-A3D4-19E131916D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29687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873B3B-BE7C-E0DF-BDF5-E0454051FE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F0D5E0B-5D89-E606-BB04-67335CE696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C203C9-8523-1BB6-7798-3D9FB4A58B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0FC09-F9E9-4733-8766-1C4D2FF1BA88}" type="datetimeFigureOut">
              <a:rPr lang="en-US" smtClean="0"/>
              <a:t>5/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668324-6B49-AC8E-FEB8-04B0A5B831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F6F6C4-5B43-306E-23C1-3C939E8C1E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B00E1D-3532-4D1D-A3D4-19E131916D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0387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0EEDD73-29B1-026E-2319-0E6585130D5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989FF56-A231-76FD-D470-0226806804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8B3B190-1E30-BD26-BBA5-1306624D72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0FC09-F9E9-4733-8766-1C4D2FF1BA88}" type="datetimeFigureOut">
              <a:rPr lang="en-US" smtClean="0"/>
              <a:t>5/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530BB8-73B1-C6B2-FCB9-18C18A9AA0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52E436-FB9B-44A8-336C-C8ADDFFF00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B00E1D-3532-4D1D-A3D4-19E131916D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26293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ACF101-13E6-BEA1-1A71-6CAE2FC454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156FFC8-F1F5-F32B-08D1-609E2DBB5EC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C50B91-533F-9074-1919-CC0F93CC24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0FC09-F9E9-4733-8766-1C4D2FF1BA88}" type="datetimeFigureOut">
              <a:rPr lang="en-US" smtClean="0"/>
              <a:t>5/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0E78D1-DB4C-B394-5832-FEAD96C284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DF09E3-92A9-2556-F28F-665C16330A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B00E1D-3532-4D1D-A3D4-19E131916D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18798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1476AC-9C46-920F-6EAA-C51B177103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A38A839-7CA1-264C-AE59-D1CBC6BA51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968367-3CB9-BE2F-EBE7-DA79185B46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0FC09-F9E9-4733-8766-1C4D2FF1BA88}" type="datetimeFigureOut">
              <a:rPr lang="en-US" smtClean="0"/>
              <a:t>5/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C97C1C-1AE5-72F0-0D68-E76A5B6AAF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BB02B0-1839-25A6-15A3-090A612E16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B00E1D-3532-4D1D-A3D4-19E131916D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90369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9145DB-280F-ADBD-5C67-9822CCDED2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A1B5005-7C6C-70C0-BCA7-3AE003F2E02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9042CAA-B6FE-8859-4263-5DE6F52BD6E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12073C2-D397-40E8-3595-82664414C1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0FC09-F9E9-4733-8766-1C4D2FF1BA88}" type="datetimeFigureOut">
              <a:rPr lang="en-US" smtClean="0"/>
              <a:t>5/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A2FD0EB-8887-1F17-DD6E-C46A83F7CB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B71C8EB-6382-1059-3805-AEC608B50F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B00E1D-3532-4D1D-A3D4-19E131916D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77406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9BB01E-1682-C1D4-6629-6043323D59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925ED57-A1D8-EB67-6631-2BF4967FFA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E3C996C-C23A-4CC0-D6AE-00F937576E4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43E9394-8299-8B80-C9C5-12D677DA767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CA76237-11D4-73B3-5764-CE2604B5835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8A23AC0-42C5-ACE7-0D08-F2815D3697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0FC09-F9E9-4733-8766-1C4D2FF1BA88}" type="datetimeFigureOut">
              <a:rPr lang="en-US" smtClean="0"/>
              <a:t>5/7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7B3735D-6436-8EBC-1DED-B4C3BCA22F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BC8F149-2424-5460-F2F4-995569BF4C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B00E1D-3532-4D1D-A3D4-19E131916D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09717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6A6FB3-55F3-575A-E033-3049C88746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4DA3D4E-7DD7-33DA-FD51-E794A023C8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0FC09-F9E9-4733-8766-1C4D2FF1BA88}" type="datetimeFigureOut">
              <a:rPr lang="en-US" smtClean="0"/>
              <a:t>5/7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5543D45-391B-DD69-57BC-7CB4ACC300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8BF54A6-6CB7-6E82-0270-6993A43A4C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B00E1D-3532-4D1D-A3D4-19E131916D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52415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28B1E32-26FE-560A-8D47-833214B907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0FC09-F9E9-4733-8766-1C4D2FF1BA88}" type="datetimeFigureOut">
              <a:rPr lang="en-US" smtClean="0"/>
              <a:t>5/7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F8D99C4-767A-ABB1-BE65-44CA5716BF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91AC684-C4BE-1277-E8A3-CB88566E20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B00E1D-3532-4D1D-A3D4-19E131916D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3744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DF6402-C485-C5E9-D428-59F8BCB372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60F1CB3-AD10-2D2E-62CA-1731BAB77A5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5444C37-B6E8-4A41-588F-9C035B3E144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99C37A7-A3F7-2884-3EB2-C111A6F41F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0FC09-F9E9-4733-8766-1C4D2FF1BA88}" type="datetimeFigureOut">
              <a:rPr lang="en-US" smtClean="0"/>
              <a:t>5/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13F0CD5-30A5-2D94-7714-D06141B289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BC373A7-050A-B8CA-D0FC-3A5BC2EED2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B00E1D-3532-4D1D-A3D4-19E131916D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86750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F57E99-CA26-E2AE-EC9F-DDB5203B50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667B62A-1997-29D7-5EDC-EA043B37CD1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F91554C-9CA3-6B45-5952-C0321847CD6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F31DB3B-B552-9410-770A-1CFF5EC0FD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0FC09-F9E9-4733-8766-1C4D2FF1BA88}" type="datetimeFigureOut">
              <a:rPr lang="en-US" smtClean="0"/>
              <a:t>5/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B934C42-EE27-4C0D-ABA1-816C9E75AE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B79D824-5B2E-5148-518F-5053E6F416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B00E1D-3532-4D1D-A3D4-19E131916D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95763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7A2F597-2889-F5E7-9F4F-999087757C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8F58761-4D9D-6402-E55E-0AC3C35BE1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A045D8-3B5C-77C4-6A7E-8D8F785E244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7A0FC09-F9E9-4733-8766-1C4D2FF1BA88}" type="datetimeFigureOut">
              <a:rPr lang="en-US" smtClean="0"/>
              <a:t>5/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5C5DE6-BC3D-E8A0-C08F-A13EF8A52BE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53E6B3-E53E-2F4D-8B85-09662CDD33B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0B00E1D-3532-4D1D-A3D4-19E131916D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74870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3251" y="3745571"/>
            <a:ext cx="3385648" cy="2511394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13749898-5BF3-8920-9127-0AC741880BCD}"/>
              </a:ext>
            </a:extLst>
          </p:cNvPr>
          <p:cNvSpPr txBox="1"/>
          <p:nvPr/>
        </p:nvSpPr>
        <p:spPr>
          <a:xfrm>
            <a:off x="1786574" y="3468572"/>
            <a:ext cx="7990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Figure 1B</a:t>
            </a:r>
          </a:p>
        </p:txBody>
      </p:sp>
      <p:pic>
        <p:nvPicPr>
          <p:cNvPr id="23" name="Picture 22" descr="A blurry image of a test tube">
            <a:extLst>
              <a:ext uri="{FF2B5EF4-FFF2-40B4-BE49-F238E27FC236}">
                <a16:creationId xmlns:a16="http://schemas.microsoft.com/office/drawing/2014/main" id="{F70F4FE0-780F-E6CC-ADA3-48BC35DAFB8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3251" y="39684"/>
            <a:ext cx="3200797" cy="3508462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F85DD70F-3637-680F-95B5-E5A07B0C0957}"/>
              </a:ext>
            </a:extLst>
          </p:cNvPr>
          <p:cNvSpPr txBox="1"/>
          <p:nvPr/>
        </p:nvSpPr>
        <p:spPr>
          <a:xfrm>
            <a:off x="1773750" y="6454390"/>
            <a:ext cx="8118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Figure 1C</a:t>
            </a:r>
          </a:p>
        </p:txBody>
      </p:sp>
      <p:pic>
        <p:nvPicPr>
          <p:cNvPr id="27" name="Picture 26">
            <a:extLst>
              <a:ext uri="{FF2B5EF4-FFF2-40B4-BE49-F238E27FC236}">
                <a16:creationId xmlns:a16="http://schemas.microsoft.com/office/drawing/2014/main" id="{4B407C12-4031-6A52-7B59-A1D708D6A65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641099" y="120434"/>
            <a:ext cx="4392304" cy="2960559"/>
          </a:xfrm>
          <a:prstGeom prst="rect">
            <a:avLst/>
          </a:prstGeom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3A5DAB20-341D-25A1-9D02-C754288721EB}"/>
              </a:ext>
            </a:extLst>
          </p:cNvPr>
          <p:cNvSpPr txBox="1"/>
          <p:nvPr/>
        </p:nvSpPr>
        <p:spPr>
          <a:xfrm>
            <a:off x="7367229" y="3088541"/>
            <a:ext cx="12741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Figure 1D, upper</a:t>
            </a:r>
          </a:p>
        </p:txBody>
      </p:sp>
      <p:pic>
        <p:nvPicPr>
          <p:cNvPr id="30" name="Picture 29">
            <a:extLst>
              <a:ext uri="{FF2B5EF4-FFF2-40B4-BE49-F238E27FC236}">
                <a16:creationId xmlns:a16="http://schemas.microsoft.com/office/drawing/2014/main" id="{C900CC23-9DBE-A5B4-8C34-A52C18D8829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808142" y="3468572"/>
            <a:ext cx="4392303" cy="2960558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517CA225-F210-40D5-9167-DB816892E216}"/>
              </a:ext>
            </a:extLst>
          </p:cNvPr>
          <p:cNvSpPr txBox="1"/>
          <p:nvPr/>
        </p:nvSpPr>
        <p:spPr>
          <a:xfrm>
            <a:off x="7367227" y="6480646"/>
            <a:ext cx="12471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Figure 1D, lower</a:t>
            </a:r>
          </a:p>
        </p:txBody>
      </p:sp>
    </p:spTree>
    <p:extLst>
      <p:ext uri="{BB962C8B-B14F-4D97-AF65-F5344CB8AC3E}">
        <p14:creationId xmlns:p14="http://schemas.microsoft.com/office/powerpoint/2010/main" val="17422805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395A4986-FAF3-614F-4D47-080DADBB2FD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76007" y="209119"/>
            <a:ext cx="3109636" cy="2725811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9143E9BA-71A3-C8A3-C3F4-CF3D1882D4B0}"/>
              </a:ext>
            </a:extLst>
          </p:cNvPr>
          <p:cNvSpPr txBox="1"/>
          <p:nvPr/>
        </p:nvSpPr>
        <p:spPr>
          <a:xfrm>
            <a:off x="1993759" y="3085636"/>
            <a:ext cx="1101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Figure 2D, top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51128A36-212F-E2C8-3D36-49541E74D5B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81560" y="3513341"/>
            <a:ext cx="3109636" cy="2725811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453083F9-49C6-80B6-3AD3-8BDDD9B8B69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881559" y="209119"/>
            <a:ext cx="3109637" cy="2725812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FD50005D-0394-FD57-F8DC-6890D85223B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76007" y="3513341"/>
            <a:ext cx="3109636" cy="2725811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F6EC5CCA-8569-E37F-FCFE-7524C656DA67}"/>
              </a:ext>
            </a:extLst>
          </p:cNvPr>
          <p:cNvSpPr txBox="1"/>
          <p:nvPr/>
        </p:nvSpPr>
        <p:spPr>
          <a:xfrm>
            <a:off x="1772532" y="6368664"/>
            <a:ext cx="19717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Figure 2D, second from top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2B767A8-B2A2-A7A3-B72E-4C8CA2C5363C}"/>
              </a:ext>
            </a:extLst>
          </p:cNvPr>
          <p:cNvSpPr txBox="1"/>
          <p:nvPr/>
        </p:nvSpPr>
        <p:spPr>
          <a:xfrm>
            <a:off x="7712162" y="3076647"/>
            <a:ext cx="17852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Figure 2D, third from top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7E03EE1-62B9-AB76-88F1-4AAE003AE105}"/>
              </a:ext>
            </a:extLst>
          </p:cNvPr>
          <p:cNvSpPr txBox="1"/>
          <p:nvPr/>
        </p:nvSpPr>
        <p:spPr>
          <a:xfrm>
            <a:off x="7553429" y="6368664"/>
            <a:ext cx="13679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Figure 2D, bottom</a:t>
            </a:r>
          </a:p>
        </p:txBody>
      </p:sp>
    </p:spTree>
    <p:extLst>
      <p:ext uri="{BB962C8B-B14F-4D97-AF65-F5344CB8AC3E}">
        <p14:creationId xmlns:p14="http://schemas.microsoft.com/office/powerpoint/2010/main" val="7627889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F3506F36-B0F8-C169-999F-70E8AC2A6E9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5087" y="228935"/>
            <a:ext cx="3591050" cy="2394034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1034971C-2407-28F2-7548-26551FF0499D}"/>
              </a:ext>
            </a:extLst>
          </p:cNvPr>
          <p:cNvSpPr txBox="1"/>
          <p:nvPr/>
        </p:nvSpPr>
        <p:spPr>
          <a:xfrm>
            <a:off x="1788746" y="2781828"/>
            <a:ext cx="10645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Figure 2F, top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E04D2CA1-8530-A8DE-C06E-A15E779AB5E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3357" y="3212404"/>
            <a:ext cx="3591051" cy="2394034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4011A3C8-A5B1-F232-FE9F-2A52E9AA2822}"/>
              </a:ext>
            </a:extLst>
          </p:cNvPr>
          <p:cNvSpPr txBox="1"/>
          <p:nvPr/>
        </p:nvSpPr>
        <p:spPr>
          <a:xfrm>
            <a:off x="1660815" y="5760015"/>
            <a:ext cx="13306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Figure 2F, bottom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50BB6B07-8F66-AF29-2B26-767E59430C4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196137" y="387794"/>
            <a:ext cx="3439048" cy="2394034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FCB9D8C0-4153-0629-923B-86C478940814}"/>
              </a:ext>
            </a:extLst>
          </p:cNvPr>
          <p:cNvSpPr txBox="1"/>
          <p:nvPr/>
        </p:nvSpPr>
        <p:spPr>
          <a:xfrm>
            <a:off x="5049471" y="2917583"/>
            <a:ext cx="1964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upplemental Figure 1, top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096FBD00-6162-0A9D-E2A2-80C8E0FC5F1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196137" y="3330337"/>
            <a:ext cx="3439048" cy="2394034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3C9317FE-B87F-8415-2359-41E52AE16A8B}"/>
              </a:ext>
            </a:extLst>
          </p:cNvPr>
          <p:cNvSpPr txBox="1"/>
          <p:nvPr/>
        </p:nvSpPr>
        <p:spPr>
          <a:xfrm>
            <a:off x="4611305" y="5896521"/>
            <a:ext cx="28409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upplemental Figure 1, second from top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CAC6CF56-4DEF-C65E-060B-BB6E280F3D7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147864" y="391643"/>
            <a:ext cx="3439049" cy="2394034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31FF5E96-8886-9ABD-7418-18343278DA5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339594" y="3330336"/>
            <a:ext cx="3439049" cy="2394035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FE3A3BCE-EBE8-F8C1-725B-DB598F701381}"/>
              </a:ext>
            </a:extLst>
          </p:cNvPr>
          <p:cNvSpPr txBox="1"/>
          <p:nvPr/>
        </p:nvSpPr>
        <p:spPr>
          <a:xfrm>
            <a:off x="8540133" y="2917582"/>
            <a:ext cx="26545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upplemental Figure 1, third from top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346E3FA3-6BE7-7517-AF58-7ADA227E5827}"/>
              </a:ext>
            </a:extLst>
          </p:cNvPr>
          <p:cNvSpPr txBox="1"/>
          <p:nvPr/>
        </p:nvSpPr>
        <p:spPr>
          <a:xfrm>
            <a:off x="9153246" y="5860126"/>
            <a:ext cx="22371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upplemental Figure 1, bottom</a:t>
            </a:r>
          </a:p>
        </p:txBody>
      </p:sp>
    </p:spTree>
    <p:extLst>
      <p:ext uri="{BB962C8B-B14F-4D97-AF65-F5344CB8AC3E}">
        <p14:creationId xmlns:p14="http://schemas.microsoft.com/office/powerpoint/2010/main" val="24569075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4</TotalTime>
  <Words>64</Words>
  <Application>Microsoft Office PowerPoint</Application>
  <PresentationFormat>Widescreen</PresentationFormat>
  <Paragraphs>14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</vt:vector>
  </TitlesOfParts>
  <Company>Duke Healt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ristin Anderson, Ph.D.</dc:creator>
  <cp:lastModifiedBy>Kristin Anderson, Ph.D.</cp:lastModifiedBy>
  <cp:revision>4</cp:revision>
  <dcterms:created xsi:type="dcterms:W3CDTF">2025-03-25T18:55:05Z</dcterms:created>
  <dcterms:modified xsi:type="dcterms:W3CDTF">2025-05-07T16:12:50Z</dcterms:modified>
</cp:coreProperties>
</file>